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43">
            <a:extLst>
              <a:ext uri="{FF2B5EF4-FFF2-40B4-BE49-F238E27FC236}">
                <a16:creationId xmlns:a16="http://schemas.microsoft.com/office/drawing/2014/main" id="{014BC63F-3F49-4174-81A5-28C6C1D9249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471" y="4891224"/>
            <a:ext cx="4681865" cy="18540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E8E45254-C0B1-415C-A3D5-40214EB5944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255" y="3133644"/>
            <a:ext cx="4491595" cy="189360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E052CD60-924F-4B9A-91DB-55C64D8117AF}"/>
              </a:ext>
            </a:extLst>
          </p:cNvPr>
          <p:cNvSpPr txBox="1"/>
          <p:nvPr/>
        </p:nvSpPr>
        <p:spPr>
          <a:xfrm flipV="1">
            <a:off x="895282" y="3379710"/>
            <a:ext cx="323165" cy="14559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Ratio to rosette leaves</a:t>
            </a:r>
            <a:endParaRPr lang="zh-CN" alt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2ADDFCB-1C99-4CAD-9D4C-11E5C625FB38}"/>
              </a:ext>
            </a:extLst>
          </p:cNvPr>
          <p:cNvSpPr txBox="1"/>
          <p:nvPr/>
        </p:nvSpPr>
        <p:spPr>
          <a:xfrm>
            <a:off x="762515" y="3101565"/>
            <a:ext cx="314510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8450C0C-543B-4747-85B7-68F68A38FBE3}"/>
              </a:ext>
            </a:extLst>
          </p:cNvPr>
          <p:cNvSpPr txBox="1"/>
          <p:nvPr/>
        </p:nvSpPr>
        <p:spPr>
          <a:xfrm>
            <a:off x="762515" y="4788816"/>
            <a:ext cx="314510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B309887-6D7A-4A0F-B230-1D54CD6CD6FA}"/>
              </a:ext>
            </a:extLst>
          </p:cNvPr>
          <p:cNvSpPr txBox="1"/>
          <p:nvPr/>
        </p:nvSpPr>
        <p:spPr>
          <a:xfrm flipV="1">
            <a:off x="895282" y="5024081"/>
            <a:ext cx="323165" cy="132359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Ratio to rosette leaves</a:t>
            </a:r>
            <a:endParaRPr lang="zh-CN" alt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ABF7102B-7D00-45DA-9E02-D9F37074060D}"/>
              </a:ext>
            </a:extLst>
          </p:cNvPr>
          <p:cNvSpPr/>
          <p:nvPr/>
        </p:nvSpPr>
        <p:spPr>
          <a:xfrm>
            <a:off x="5256064" y="4126519"/>
            <a:ext cx="135931" cy="1034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8F19CAF-0D85-4F13-BAF2-562E3360AE61}"/>
              </a:ext>
            </a:extLst>
          </p:cNvPr>
          <p:cNvSpPr txBox="1"/>
          <p:nvPr/>
        </p:nvSpPr>
        <p:spPr>
          <a:xfrm>
            <a:off x="5352349" y="4068104"/>
            <a:ext cx="603050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eedling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60105AAD-E6A2-4C01-B141-D2B673C20F83}"/>
              </a:ext>
            </a:extLst>
          </p:cNvPr>
          <p:cNvSpPr/>
          <p:nvPr/>
        </p:nvSpPr>
        <p:spPr>
          <a:xfrm>
            <a:off x="5256064" y="4329364"/>
            <a:ext cx="135931" cy="103488"/>
          </a:xfrm>
          <a:prstGeom prst="rect">
            <a:avLst/>
          </a:prstGeom>
          <a:solidFill>
            <a:srgbClr val="D4D4D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C097800C-7746-4B10-99AA-258856C78FDF}"/>
              </a:ext>
            </a:extLst>
          </p:cNvPr>
          <p:cNvSpPr/>
          <p:nvPr/>
        </p:nvSpPr>
        <p:spPr>
          <a:xfrm>
            <a:off x="5256064" y="4532208"/>
            <a:ext cx="135931" cy="103488"/>
          </a:xfrm>
          <a:prstGeom prst="rect">
            <a:avLst/>
          </a:prstGeom>
          <a:solidFill>
            <a:srgbClr val="80808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C7AF8C49-E7CF-41C5-A1EF-8B1C2B32C50C}"/>
              </a:ext>
            </a:extLst>
          </p:cNvPr>
          <p:cNvSpPr/>
          <p:nvPr/>
        </p:nvSpPr>
        <p:spPr>
          <a:xfrm>
            <a:off x="5256064" y="4735052"/>
            <a:ext cx="135931" cy="103488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6E9F0DDC-FF45-4A4F-96FE-43E681801129}"/>
              </a:ext>
            </a:extLst>
          </p:cNvPr>
          <p:cNvSpPr/>
          <p:nvPr/>
        </p:nvSpPr>
        <p:spPr>
          <a:xfrm>
            <a:off x="5256064" y="4937897"/>
            <a:ext cx="135931" cy="103488"/>
          </a:xfrm>
          <a:prstGeom prst="rect">
            <a:avLst/>
          </a:prstGeom>
          <a:solidFill>
            <a:srgbClr val="A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4568652B-ADA2-4964-A011-5B4BC25D4994}"/>
              </a:ext>
            </a:extLst>
          </p:cNvPr>
          <p:cNvSpPr/>
          <p:nvPr/>
        </p:nvSpPr>
        <p:spPr>
          <a:xfrm>
            <a:off x="5256064" y="5140741"/>
            <a:ext cx="135931" cy="103488"/>
          </a:xfrm>
          <a:prstGeom prst="rect">
            <a:avLst/>
          </a:prstGeom>
          <a:solidFill>
            <a:srgbClr val="FFA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BEE6E25D-1115-499D-85E3-45DC512E8F0F}"/>
              </a:ext>
            </a:extLst>
          </p:cNvPr>
          <p:cNvSpPr/>
          <p:nvPr/>
        </p:nvSpPr>
        <p:spPr>
          <a:xfrm>
            <a:off x="5256064" y="5343586"/>
            <a:ext cx="135931" cy="103488"/>
          </a:xfrm>
          <a:prstGeom prst="rect">
            <a:avLst/>
          </a:prstGeom>
          <a:solidFill>
            <a:srgbClr val="FFE0E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7CEC6FB9-19C5-4529-847E-5157678F600B}"/>
              </a:ext>
            </a:extLst>
          </p:cNvPr>
          <p:cNvSpPr txBox="1"/>
          <p:nvPr/>
        </p:nvSpPr>
        <p:spPr>
          <a:xfrm>
            <a:off x="5352349" y="4270948"/>
            <a:ext cx="50206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2ED80556-14BA-42C8-93C9-6B8088EBBB5D}"/>
              </a:ext>
            </a:extLst>
          </p:cNvPr>
          <p:cNvSpPr txBox="1"/>
          <p:nvPr/>
        </p:nvSpPr>
        <p:spPr>
          <a:xfrm>
            <a:off x="5352349" y="4473793"/>
            <a:ext cx="441146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oot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1201DE1-EBC8-4731-8B49-467E2C080EB1}"/>
              </a:ext>
            </a:extLst>
          </p:cNvPr>
          <p:cNvSpPr txBox="1"/>
          <p:nvPr/>
        </p:nvSpPr>
        <p:spPr>
          <a:xfrm>
            <a:off x="5352349" y="4676637"/>
            <a:ext cx="87395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osette leave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B557DCB-2F44-46DD-AC9A-4F8488289F0F}"/>
              </a:ext>
            </a:extLst>
          </p:cNvPr>
          <p:cNvSpPr txBox="1"/>
          <p:nvPr/>
        </p:nvSpPr>
        <p:spPr>
          <a:xfrm>
            <a:off x="5352349" y="4879482"/>
            <a:ext cx="54534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lower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CEFD1A66-2EAC-423C-BAA6-659CCADA9DA3}"/>
              </a:ext>
            </a:extLst>
          </p:cNvPr>
          <p:cNvSpPr txBox="1"/>
          <p:nvPr/>
        </p:nvSpPr>
        <p:spPr>
          <a:xfrm>
            <a:off x="5352349" y="5082326"/>
            <a:ext cx="848309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young siliqu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ED88E999-8DBE-4C6F-B931-8F9B83A9D0D4}"/>
              </a:ext>
            </a:extLst>
          </p:cNvPr>
          <p:cNvSpPr txBox="1"/>
          <p:nvPr/>
        </p:nvSpPr>
        <p:spPr>
          <a:xfrm>
            <a:off x="5352349" y="5285170"/>
            <a:ext cx="69442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old siliqu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41">
            <a:extLst>
              <a:ext uri="{FF2B5EF4-FFF2-40B4-BE49-F238E27FC236}">
                <a16:creationId xmlns:a16="http://schemas.microsoft.com/office/drawing/2014/main" id="{51DAA90E-23F6-44B9-AC0E-1E7FDB8AF752}"/>
              </a:ext>
            </a:extLst>
          </p:cNvPr>
          <p:cNvSpPr/>
          <p:nvPr/>
        </p:nvSpPr>
        <p:spPr>
          <a:xfrm>
            <a:off x="1052610" y="6330973"/>
            <a:ext cx="232756" cy="1717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42">
            <a:extLst>
              <a:ext uri="{FF2B5EF4-FFF2-40B4-BE49-F238E27FC236}">
                <a16:creationId xmlns:a16="http://schemas.microsoft.com/office/drawing/2014/main" id="{D2408BEB-260B-475E-B260-295E9748441A}"/>
              </a:ext>
            </a:extLst>
          </p:cNvPr>
          <p:cNvSpPr txBox="1"/>
          <p:nvPr/>
        </p:nvSpPr>
        <p:spPr>
          <a:xfrm>
            <a:off x="1135738" y="6342058"/>
            <a:ext cx="24237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10">
            <a:extLst>
              <a:ext uri="{FF2B5EF4-FFF2-40B4-BE49-F238E27FC236}">
                <a16:creationId xmlns:a16="http://schemas.microsoft.com/office/drawing/2014/main" id="{0FBEA3F5-420D-4731-AAEC-8358F4929900}"/>
              </a:ext>
            </a:extLst>
          </p:cNvPr>
          <p:cNvSpPr txBox="1"/>
          <p:nvPr/>
        </p:nvSpPr>
        <p:spPr>
          <a:xfrm>
            <a:off x="1801782" y="5579081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43">
            <a:extLst>
              <a:ext uri="{FF2B5EF4-FFF2-40B4-BE49-F238E27FC236}">
                <a16:creationId xmlns:a16="http://schemas.microsoft.com/office/drawing/2014/main" id="{6B3BC7FB-5068-475E-84FE-12E55CBA715E}"/>
              </a:ext>
            </a:extLst>
          </p:cNvPr>
          <p:cNvSpPr txBox="1"/>
          <p:nvPr/>
        </p:nvSpPr>
        <p:spPr>
          <a:xfrm>
            <a:off x="2329993" y="565078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44">
            <a:extLst>
              <a:ext uri="{FF2B5EF4-FFF2-40B4-BE49-F238E27FC236}">
                <a16:creationId xmlns:a16="http://schemas.microsoft.com/office/drawing/2014/main" id="{9C82FCE4-7905-450C-B6B2-C5D57EBD0D9C}"/>
              </a:ext>
            </a:extLst>
          </p:cNvPr>
          <p:cNvSpPr txBox="1"/>
          <p:nvPr/>
        </p:nvSpPr>
        <p:spPr>
          <a:xfrm>
            <a:off x="2444076" y="559453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45">
            <a:extLst>
              <a:ext uri="{FF2B5EF4-FFF2-40B4-BE49-F238E27FC236}">
                <a16:creationId xmlns:a16="http://schemas.microsoft.com/office/drawing/2014/main" id="{80A42E77-F7B3-4803-95F3-7C62F4C7F69B}"/>
              </a:ext>
            </a:extLst>
          </p:cNvPr>
          <p:cNvSpPr txBox="1"/>
          <p:nvPr/>
        </p:nvSpPr>
        <p:spPr>
          <a:xfrm>
            <a:off x="2595400" y="5456020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46">
            <a:extLst>
              <a:ext uri="{FF2B5EF4-FFF2-40B4-BE49-F238E27FC236}">
                <a16:creationId xmlns:a16="http://schemas.microsoft.com/office/drawing/2014/main" id="{018AD505-E3F1-4AE3-BC5F-32CC1E720E66}"/>
              </a:ext>
            </a:extLst>
          </p:cNvPr>
          <p:cNvSpPr txBox="1"/>
          <p:nvPr/>
        </p:nvSpPr>
        <p:spPr>
          <a:xfrm>
            <a:off x="2812556" y="5658480"/>
            <a:ext cx="444382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47">
            <a:extLst>
              <a:ext uri="{FF2B5EF4-FFF2-40B4-BE49-F238E27FC236}">
                <a16:creationId xmlns:a16="http://schemas.microsoft.com/office/drawing/2014/main" id="{1EB276DB-0D3C-4041-97B2-659B20C6B3EB}"/>
              </a:ext>
            </a:extLst>
          </p:cNvPr>
          <p:cNvSpPr txBox="1"/>
          <p:nvPr/>
        </p:nvSpPr>
        <p:spPr>
          <a:xfrm>
            <a:off x="2933859" y="5541753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48">
            <a:extLst>
              <a:ext uri="{FF2B5EF4-FFF2-40B4-BE49-F238E27FC236}">
                <a16:creationId xmlns:a16="http://schemas.microsoft.com/office/drawing/2014/main" id="{77F217B0-AFB1-4DED-9646-182C3BFDCA83}"/>
              </a:ext>
            </a:extLst>
          </p:cNvPr>
          <p:cNvSpPr txBox="1"/>
          <p:nvPr/>
        </p:nvSpPr>
        <p:spPr>
          <a:xfrm>
            <a:off x="3073342" y="577913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49">
            <a:extLst>
              <a:ext uri="{FF2B5EF4-FFF2-40B4-BE49-F238E27FC236}">
                <a16:creationId xmlns:a16="http://schemas.microsoft.com/office/drawing/2014/main" id="{2606183A-E725-4C22-BBEE-DE0A0ACBD26D}"/>
              </a:ext>
            </a:extLst>
          </p:cNvPr>
          <p:cNvSpPr txBox="1"/>
          <p:nvPr/>
        </p:nvSpPr>
        <p:spPr>
          <a:xfrm>
            <a:off x="3838201" y="559453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50">
            <a:extLst>
              <a:ext uri="{FF2B5EF4-FFF2-40B4-BE49-F238E27FC236}">
                <a16:creationId xmlns:a16="http://schemas.microsoft.com/office/drawing/2014/main" id="{72F5165C-9BEC-4065-8A68-A304920BE663}"/>
              </a:ext>
            </a:extLst>
          </p:cNvPr>
          <p:cNvSpPr txBox="1"/>
          <p:nvPr/>
        </p:nvSpPr>
        <p:spPr>
          <a:xfrm>
            <a:off x="4602434" y="5655728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51">
            <a:extLst>
              <a:ext uri="{FF2B5EF4-FFF2-40B4-BE49-F238E27FC236}">
                <a16:creationId xmlns:a16="http://schemas.microsoft.com/office/drawing/2014/main" id="{A2D9793D-0E88-4A1F-B973-175569B89A62}"/>
              </a:ext>
            </a:extLst>
          </p:cNvPr>
          <p:cNvSpPr txBox="1"/>
          <p:nvPr/>
        </p:nvSpPr>
        <p:spPr>
          <a:xfrm>
            <a:off x="4827963" y="5979906"/>
            <a:ext cx="444382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52">
            <a:extLst>
              <a:ext uri="{FF2B5EF4-FFF2-40B4-BE49-F238E27FC236}">
                <a16:creationId xmlns:a16="http://schemas.microsoft.com/office/drawing/2014/main" id="{4B31825D-E7FF-4256-BFB3-1AFF707CCD92}"/>
              </a:ext>
            </a:extLst>
          </p:cNvPr>
          <p:cNvSpPr txBox="1"/>
          <p:nvPr/>
        </p:nvSpPr>
        <p:spPr>
          <a:xfrm>
            <a:off x="4941152" y="5911483"/>
            <a:ext cx="444382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53">
            <a:extLst>
              <a:ext uri="{FF2B5EF4-FFF2-40B4-BE49-F238E27FC236}">
                <a16:creationId xmlns:a16="http://schemas.microsoft.com/office/drawing/2014/main" id="{9A1786AC-9219-4FE2-890C-A861970C874B}"/>
              </a:ext>
            </a:extLst>
          </p:cNvPr>
          <p:cNvSpPr txBox="1"/>
          <p:nvPr/>
        </p:nvSpPr>
        <p:spPr>
          <a:xfrm>
            <a:off x="5073253" y="577286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54">
            <a:extLst>
              <a:ext uri="{FF2B5EF4-FFF2-40B4-BE49-F238E27FC236}">
                <a16:creationId xmlns:a16="http://schemas.microsoft.com/office/drawing/2014/main" id="{457C51D1-442E-4ABC-867D-514488E54451}"/>
              </a:ext>
            </a:extLst>
          </p:cNvPr>
          <p:cNvSpPr txBox="1"/>
          <p:nvPr/>
        </p:nvSpPr>
        <p:spPr>
          <a:xfrm>
            <a:off x="1871502" y="3365769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55">
            <a:extLst>
              <a:ext uri="{FF2B5EF4-FFF2-40B4-BE49-F238E27FC236}">
                <a16:creationId xmlns:a16="http://schemas.microsoft.com/office/drawing/2014/main" id="{89E40430-3E75-41FB-818A-CA7E49BC98D6}"/>
              </a:ext>
            </a:extLst>
          </p:cNvPr>
          <p:cNvSpPr txBox="1"/>
          <p:nvPr/>
        </p:nvSpPr>
        <p:spPr>
          <a:xfrm>
            <a:off x="2325131" y="334207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56">
            <a:extLst>
              <a:ext uri="{FF2B5EF4-FFF2-40B4-BE49-F238E27FC236}">
                <a16:creationId xmlns:a16="http://schemas.microsoft.com/office/drawing/2014/main" id="{0858D704-CAC7-47A6-A802-52EEB794E1E1}"/>
              </a:ext>
            </a:extLst>
          </p:cNvPr>
          <p:cNvSpPr txBox="1"/>
          <p:nvPr/>
        </p:nvSpPr>
        <p:spPr>
          <a:xfrm>
            <a:off x="2558181" y="3310071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57">
            <a:extLst>
              <a:ext uri="{FF2B5EF4-FFF2-40B4-BE49-F238E27FC236}">
                <a16:creationId xmlns:a16="http://schemas.microsoft.com/office/drawing/2014/main" id="{65E18AB3-0687-4821-A769-4699809EED2E}"/>
              </a:ext>
            </a:extLst>
          </p:cNvPr>
          <p:cNvSpPr txBox="1"/>
          <p:nvPr/>
        </p:nvSpPr>
        <p:spPr>
          <a:xfrm>
            <a:off x="2813509" y="3604698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58">
            <a:extLst>
              <a:ext uri="{FF2B5EF4-FFF2-40B4-BE49-F238E27FC236}">
                <a16:creationId xmlns:a16="http://schemas.microsoft.com/office/drawing/2014/main" id="{BBA528E0-3148-4A7D-8608-2555CD3A2E4F}"/>
              </a:ext>
            </a:extLst>
          </p:cNvPr>
          <p:cNvSpPr txBox="1"/>
          <p:nvPr/>
        </p:nvSpPr>
        <p:spPr>
          <a:xfrm>
            <a:off x="3368266" y="3797553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59">
            <a:extLst>
              <a:ext uri="{FF2B5EF4-FFF2-40B4-BE49-F238E27FC236}">
                <a16:creationId xmlns:a16="http://schemas.microsoft.com/office/drawing/2014/main" id="{4897B7DC-0E7E-442F-B17D-393365B57112}"/>
              </a:ext>
            </a:extLst>
          </p:cNvPr>
          <p:cNvSpPr txBox="1"/>
          <p:nvPr/>
        </p:nvSpPr>
        <p:spPr>
          <a:xfrm>
            <a:off x="3812648" y="3794055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60">
            <a:extLst>
              <a:ext uri="{FF2B5EF4-FFF2-40B4-BE49-F238E27FC236}">
                <a16:creationId xmlns:a16="http://schemas.microsoft.com/office/drawing/2014/main" id="{8AB77DAA-9441-4E7B-9912-D48807E32F9F}"/>
              </a:ext>
            </a:extLst>
          </p:cNvPr>
          <p:cNvSpPr txBox="1"/>
          <p:nvPr/>
        </p:nvSpPr>
        <p:spPr>
          <a:xfrm>
            <a:off x="4257030" y="3579957"/>
            <a:ext cx="665118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61">
            <a:extLst>
              <a:ext uri="{FF2B5EF4-FFF2-40B4-BE49-F238E27FC236}">
                <a16:creationId xmlns:a16="http://schemas.microsoft.com/office/drawing/2014/main" id="{B4BF83B6-46AA-42C7-BC6F-72A4CA8D726A}"/>
              </a:ext>
            </a:extLst>
          </p:cNvPr>
          <p:cNvSpPr txBox="1"/>
          <p:nvPr/>
        </p:nvSpPr>
        <p:spPr>
          <a:xfrm>
            <a:off x="4492066" y="3342076"/>
            <a:ext cx="665118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62">
            <a:extLst>
              <a:ext uri="{FF2B5EF4-FFF2-40B4-BE49-F238E27FC236}">
                <a16:creationId xmlns:a16="http://schemas.microsoft.com/office/drawing/2014/main" id="{125DB1E8-04E0-4594-8AC8-6724B2156FD0}"/>
              </a:ext>
            </a:extLst>
          </p:cNvPr>
          <p:cNvSpPr txBox="1"/>
          <p:nvPr/>
        </p:nvSpPr>
        <p:spPr>
          <a:xfrm>
            <a:off x="4730844" y="3691256"/>
            <a:ext cx="444382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E325FC90-3854-4D72-8C61-EE9965FB3F7B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436" y="647463"/>
            <a:ext cx="2925255" cy="2660947"/>
          </a:xfrm>
          <a:prstGeom prst="rect">
            <a:avLst/>
          </a:prstGeom>
        </p:spPr>
      </p:pic>
      <p:sp>
        <p:nvSpPr>
          <p:cNvPr id="88" name="文本框 12">
            <a:extLst>
              <a:ext uri="{FF2B5EF4-FFF2-40B4-BE49-F238E27FC236}">
                <a16:creationId xmlns:a16="http://schemas.microsoft.com/office/drawing/2014/main" id="{22512CC8-CED9-4F15-92C0-2A43CA6EE5AC}"/>
              </a:ext>
            </a:extLst>
          </p:cNvPr>
          <p:cNvSpPr txBox="1"/>
          <p:nvPr/>
        </p:nvSpPr>
        <p:spPr>
          <a:xfrm>
            <a:off x="762515" y="544913"/>
            <a:ext cx="314510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111F53BE-D4B3-483F-9538-C6452CEC637A}"/>
              </a:ext>
            </a:extLst>
          </p:cNvPr>
          <p:cNvSpPr txBox="1"/>
          <p:nvPr/>
        </p:nvSpPr>
        <p:spPr>
          <a:xfrm>
            <a:off x="1636319" y="2418495"/>
            <a:ext cx="35031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I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9521A5D-67BC-4784-B56B-52631C0C9439}"/>
              </a:ext>
            </a:extLst>
          </p:cNvPr>
          <p:cNvSpPr txBox="1"/>
          <p:nvPr/>
        </p:nvSpPr>
        <p:spPr>
          <a:xfrm>
            <a:off x="1523436" y="2099849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L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D10B3D8F-735F-4693-AEC2-CC8E4A701C2D}"/>
              </a:ext>
            </a:extLst>
          </p:cNvPr>
          <p:cNvSpPr txBox="1"/>
          <p:nvPr/>
        </p:nvSpPr>
        <p:spPr>
          <a:xfrm>
            <a:off x="1554327" y="1735278"/>
            <a:ext cx="34015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X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540EFD42-955C-45D1-8DD4-A37112264612}"/>
              </a:ext>
            </a:extLst>
          </p:cNvPr>
          <p:cNvSpPr txBox="1"/>
          <p:nvPr/>
        </p:nvSpPr>
        <p:spPr>
          <a:xfrm>
            <a:off x="1641399" y="1333044"/>
            <a:ext cx="34015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X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B810F87C-787D-4778-B44E-620031702D44}"/>
              </a:ext>
            </a:extLst>
          </p:cNvPr>
          <p:cNvSpPr txBox="1"/>
          <p:nvPr/>
        </p:nvSpPr>
        <p:spPr>
          <a:xfrm>
            <a:off x="1967106" y="1002229"/>
            <a:ext cx="348172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K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0612F22A-DB1B-42EC-8F4C-D778019D1DC8}"/>
              </a:ext>
            </a:extLst>
          </p:cNvPr>
          <p:cNvSpPr txBox="1"/>
          <p:nvPr/>
        </p:nvSpPr>
        <p:spPr>
          <a:xfrm>
            <a:off x="2187476" y="879109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L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1D075EEB-929F-4885-B2A9-7B921BBF58BF}"/>
              </a:ext>
            </a:extLst>
          </p:cNvPr>
          <p:cNvSpPr txBox="1"/>
          <p:nvPr/>
        </p:nvSpPr>
        <p:spPr>
          <a:xfrm>
            <a:off x="2669403" y="641529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4DEC1002-698F-42E4-8CE5-8C50BF3200E7}"/>
              </a:ext>
            </a:extLst>
          </p:cNvPr>
          <p:cNvSpPr txBox="1"/>
          <p:nvPr/>
        </p:nvSpPr>
        <p:spPr>
          <a:xfrm>
            <a:off x="2914414" y="606469"/>
            <a:ext cx="53251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28035AA4-5867-412E-812B-885CFD870241}"/>
              </a:ext>
            </a:extLst>
          </p:cNvPr>
          <p:cNvSpPr txBox="1"/>
          <p:nvPr/>
        </p:nvSpPr>
        <p:spPr>
          <a:xfrm>
            <a:off x="3349404" y="752399"/>
            <a:ext cx="348172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K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C133A4EE-484A-4890-AD3F-BE324BE58076}"/>
              </a:ext>
            </a:extLst>
          </p:cNvPr>
          <p:cNvSpPr txBox="1"/>
          <p:nvPr/>
        </p:nvSpPr>
        <p:spPr>
          <a:xfrm>
            <a:off x="3574801" y="879109"/>
            <a:ext cx="29046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I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9A4D8240-1C7B-4EFF-8ED5-C57821F0DBA1}"/>
              </a:ext>
            </a:extLst>
          </p:cNvPr>
          <p:cNvSpPr txBox="1"/>
          <p:nvPr/>
        </p:nvSpPr>
        <p:spPr>
          <a:xfrm>
            <a:off x="3980293" y="1430054"/>
            <a:ext cx="42511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E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97968FA0-D497-40FB-B3C0-069F796754FE}"/>
              </a:ext>
            </a:extLst>
          </p:cNvPr>
          <p:cNvSpPr txBox="1"/>
          <p:nvPr/>
        </p:nvSpPr>
        <p:spPr>
          <a:xfrm>
            <a:off x="3986705" y="1553089"/>
            <a:ext cx="33374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17AE3600-A471-4326-96EB-3EF808538314}"/>
              </a:ext>
            </a:extLst>
          </p:cNvPr>
          <p:cNvSpPr txBox="1"/>
          <p:nvPr/>
        </p:nvSpPr>
        <p:spPr>
          <a:xfrm>
            <a:off x="4022773" y="1676199"/>
            <a:ext cx="42511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E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D44FD66-835A-48F6-9965-1BFA2759CEAE}"/>
              </a:ext>
            </a:extLst>
          </p:cNvPr>
          <p:cNvSpPr txBox="1"/>
          <p:nvPr/>
        </p:nvSpPr>
        <p:spPr>
          <a:xfrm>
            <a:off x="3868438" y="2746964"/>
            <a:ext cx="41069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18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28F1673A-6231-4625-89B9-A1FE7E7A2C5D}"/>
              </a:ext>
            </a:extLst>
          </p:cNvPr>
          <p:cNvSpPr txBox="1"/>
          <p:nvPr/>
        </p:nvSpPr>
        <p:spPr>
          <a:xfrm>
            <a:off x="2507182" y="1879610"/>
            <a:ext cx="800219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tDN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367,808bp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FF439FF-766F-904D-B8FF-6F4BDF38324F}"/>
              </a:ext>
            </a:extLst>
          </p:cNvPr>
          <p:cNvSpPr/>
          <p:nvPr/>
        </p:nvSpPr>
        <p:spPr>
          <a:xfrm>
            <a:off x="350156" y="6800902"/>
            <a:ext cx="6181271" cy="29759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5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6 Fig. Changes in </a:t>
            </a:r>
            <a:r>
              <a:rPr lang="en-US" sz="1050" b="1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tDNA</a:t>
            </a:r>
            <a:r>
              <a:rPr lang="en-US" sz="105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copy number and HR frequency during development.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endParaRPr lang="en-CN" sz="14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5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Schematic map of Arabidopsis </a:t>
            </a:r>
            <a:r>
              <a:rPr lang="en-US" sz="105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tDNA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. Six repeat pairs are indicated in the map.</a:t>
            </a:r>
            <a:r>
              <a:rPr lang="en-US" sz="105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B) 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Relative quantification of copy numbers of </a:t>
            </a:r>
            <a:r>
              <a:rPr lang="en-US" sz="105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tDNA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(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18S, COX2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) gene sequences in different tissues of Col-0. Nuclear genes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UBC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and 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CT2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were used as reference genes.</a:t>
            </a:r>
            <a:r>
              <a:rPr lang="en-US" sz="105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C) 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Relative quantification of the crossover products (as depicted in Fig. 5B) of L and EE in different tissues of Col-0. Mitochondrial genes 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18S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and 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COX2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were used as reference genes. Data are normalized to rosette leaves and shown as mean values ± SD; circles show the original data of six repeats containing two biological replicates.</a:t>
            </a:r>
            <a:endParaRPr lang="en-CN" sz="14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One-way ANOVA compared to rosette leaves for each locus. *, 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&lt; 0.05;</a:t>
            </a:r>
            <a:r>
              <a:rPr lang="nn-NO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 **, </a:t>
            </a:r>
            <a:r>
              <a:rPr lang="nn-NO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nn-NO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&lt; 0.01; ***, </a:t>
            </a:r>
            <a:r>
              <a:rPr lang="nn-NO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nn-NO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&lt; 0.001; ****, </a:t>
            </a:r>
            <a:r>
              <a:rPr lang="nn-NO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nn-NO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&lt; 0.0001. 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The data underlying this figure can be found in S1 Data. </a:t>
            </a:r>
            <a:r>
              <a:rPr lang="en-US" sz="105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tDNA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, mitochondrial DNA; HR,</a:t>
            </a:r>
            <a:r>
              <a:rPr lang="en-US" sz="105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 homologous recombination; 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COX2</a:t>
            </a:r>
            <a:r>
              <a:rPr lang="en-US" sz="1050" kern="100" dirty="0">
                <a:latin typeface="Arial" panose="020B0604020202020204" pitchFamily="34" charset="0"/>
                <a:ea typeface="SimSun" panose="02010600030101010101" pitchFamily="2" charset="-122"/>
              </a:rPr>
              <a:t>,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5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CYTOCHROME OXIDASE 2</a:t>
            </a:r>
            <a:r>
              <a:rPr lang="en-US" sz="105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; </a:t>
            </a:r>
            <a:r>
              <a:rPr lang="en-US" sz="105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UBC</a:t>
            </a:r>
            <a:r>
              <a:rPr lang="en-US" sz="105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05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 UBIQUITIN-CONJUGATING ENZYME;</a:t>
            </a:r>
            <a:r>
              <a:rPr lang="en-US" sz="105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CT2,</a:t>
            </a: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050" i="1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 ACTIN 2</a:t>
            </a:r>
            <a:r>
              <a:rPr lang="en-US" sz="105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; </a:t>
            </a:r>
            <a:r>
              <a:rPr lang="en-US" sz="1050" kern="1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Helvetica" pitchFamily="2" charset="0"/>
              </a:rPr>
              <a:t>ANOVA, analysis of variance.</a:t>
            </a:r>
            <a:endParaRPr lang="en-CN" sz="14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8384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264</Words>
  <Application>Microsoft Macintosh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Helvetica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51:28Z</dcterms:modified>
</cp:coreProperties>
</file>